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8" r:id="rId2"/>
    <p:sldId id="279" r:id="rId3"/>
    <p:sldId id="280" r:id="rId4"/>
    <p:sldId id="281" r:id="rId5"/>
    <p:sldId id="282" r:id="rId6"/>
    <p:sldId id="283" r:id="rId7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3" d="100"/>
          <a:sy n="73" d="100"/>
        </p:scale>
        <p:origin x="325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3E262A-1C74-6D1E-3CD5-2F40B24EFCC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en-US"/>
              <a:t>Click to edit Master title style</a:t>
            </a:r>
            <a:endParaRPr lang="fr-B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B1673CB-0737-AA81-C9B9-1463FF3E546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en-US"/>
              <a:t>Click to edit Master subtitle style</a:t>
            </a:r>
            <a:endParaRPr lang="fr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776D3C-A9B7-EFD1-6FC9-06D2ABF08F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DB5C6-98F9-4FD3-AD0D-9E5DB5881817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FAAAE4-7210-DC1E-AEBD-CD8BF33351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052EC9-B8E3-BFB2-3ED0-7D70255105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BA59-9D98-41D4-84B2-C0F1BB7A7ED6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1432433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AA4996-109E-267D-AE43-406F2A3936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B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A0740A0-3703-B72D-7FC5-89F5A39474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986FE1-40A7-4DA2-7C38-0F8BC862C2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DB5C6-98F9-4FD3-AD0D-9E5DB5881817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F1354F-FE6A-18F1-C79E-7C2F06AF90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A8166E-AC70-A59F-1B2A-1E13716418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BA59-9D98-41D4-84B2-C0F1BB7A7ED6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9962348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B8A567A-00EC-A3E9-B98D-1606BA53FC1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r-B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E9D01DF-AE7B-BCA9-4E37-B59D43AF3E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D42340-1B7A-8751-5761-8AD08B0BE6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DB5C6-98F9-4FD3-AD0D-9E5DB5881817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B325C6-4FE4-D990-F5F0-A0BCF8A32E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B4B613-7B62-8F8C-0526-11708B2C53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BA59-9D98-41D4-84B2-C0F1BB7A7ED6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8289621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25AF0B-B941-1D92-AAF7-EA689B505E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B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B40ADD-1BC6-53CF-597E-1D6570DC57A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A1E0FC-2A38-9ADA-1412-099D487BE8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DB5C6-98F9-4FD3-AD0D-9E5DB5881817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98863F-5BED-8A94-3BC8-0143CF08CC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C0E7B8-16FF-0D96-57BC-FC1E4A6B22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BA59-9D98-41D4-84B2-C0F1BB7A7ED6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8299386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A2B23B-4EDD-6FCA-DB3F-BB155F21D2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en-US"/>
              <a:t>Click to edit Master title style</a:t>
            </a:r>
            <a:endParaRPr lang="fr-B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0066EB-9130-96B5-C836-80FBE98C84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82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82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82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37006F-554D-9EEA-2B4F-EEA75BD6A6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DB5C6-98F9-4FD3-AD0D-9E5DB5881817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419857-C4BE-53CD-17B4-AFDB3C37F8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E29BFF-7CE4-8ACD-7366-6A1B61F736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BA59-9D98-41D4-84B2-C0F1BB7A7ED6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6532737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1E02F3-4C80-E178-3D9C-47F3C6D18D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B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BB3AD9-B3F0-F268-C9E9-95B9A95F358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B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43CBD1C-7492-7F41-0DDC-91B60578D8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B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C2E27B1-1785-DDCD-8A84-0E252FCAAF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DB5C6-98F9-4FD3-AD0D-9E5DB5881817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105EB4E-F79D-7F27-9F36-F7F88490FA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D9E3E1-2889-239E-9F03-E93F783CAA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BA59-9D98-41D4-84B2-C0F1BB7A7ED6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791266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0CD3E7-020B-ED80-B384-C68430CCA0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r-B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454728-AEB5-4DA0-0271-4AB3BF0DFA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7E8CE97-296B-4084-41F6-9522A02C70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B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956CF76-0D66-D661-6D70-A4150748A2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C18B631-0D76-3257-FE30-F617D8E505C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B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655C6E4-6305-4029-2767-0583FE6BF7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DB5C6-98F9-4FD3-AD0D-9E5DB5881817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3224E23-83C0-5C39-3A4C-70FD275255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DDCACB6-7D01-E7A3-9372-4928A77878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BA59-9D98-41D4-84B2-C0F1BB7A7ED6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8865445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4772CB-9537-EFD2-B68D-5F2B5A55C9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B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1B0F90F-B577-A1AB-A8C9-440D4B7600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DB5C6-98F9-4FD3-AD0D-9E5DB5881817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C56764A-666E-AB6E-A0E7-060992B8B9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D2D9A6F-FEDE-8D81-0DB7-AEAE6511D6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BA59-9D98-41D4-84B2-C0F1BB7A7ED6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607918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A3A1F40-7F98-6F1B-1D13-8D381E03D7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DB5C6-98F9-4FD3-AD0D-9E5DB5881817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104DE33-9D46-2A87-BB51-B3A0AE3592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4FAD6FB-9C73-1179-2923-2C5B59E2BB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BA59-9D98-41D4-84B2-C0F1BB7A7ED6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8368307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233BC9-F6DF-5677-B43D-78216F5620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  <a:endParaRPr lang="fr-B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E411C31-DA4F-6E76-4CA0-F855A3BC9D6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B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4975005-5246-4500-5BB2-388830E9D1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568821-BB93-336B-6D5E-565D984546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DB5C6-98F9-4FD3-AD0D-9E5DB5881817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E55383C-6E71-0CBA-CA4C-1851F47B97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366560-297B-1716-3FC1-D65C22CF42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BA59-9D98-41D4-84B2-C0F1BB7A7ED6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42337182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EB6644-65FE-A7C2-F650-F42923CE50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  <a:endParaRPr lang="fr-B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FA50A45-4C7F-EECD-6323-B45E3927E60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fr-B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38C10F9-CC00-7DC7-A4F8-72CE6CDF65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0C2C967-DDD5-EA79-BC6B-84D0FB61F4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DB5C6-98F9-4FD3-AD0D-9E5DB5881817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B78EAB-E035-D471-6CCC-9496F88698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4EC157-87A4-7316-7201-06F191208B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2BA59-9D98-41D4-84B2-C0F1BB7A7ED6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0270412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D835308-20E3-97A4-A06E-F4D0E08981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r-B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7EA183C-958D-C8EC-6458-08F5512AD4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D12586-DD95-B5D3-4BE1-BFF05B98A4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91DB5C6-98F9-4FD3-AD0D-9E5DB5881817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55C81D-81A4-062C-591C-AFE89F7BC90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74ACBF-69D0-56EF-DC5D-99C8AD95C12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C02BA59-9D98-41D4-84B2-C0F1BB7A7ED6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5749965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3BFD8EE-22AF-9365-8053-3F8AF2993172}"/>
              </a:ext>
            </a:extLst>
          </p:cNvPr>
          <p:cNvSpPr txBox="1"/>
          <p:nvPr/>
        </p:nvSpPr>
        <p:spPr>
          <a:xfrm>
            <a:off x="115747" y="462024"/>
            <a:ext cx="54053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LC/MS data for every VHH-conjugate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4EC9E54-26A8-CAF4-3614-BB4BD2DD40E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267" r="9198" b="26252"/>
          <a:stretch/>
        </p:blipFill>
        <p:spPr>
          <a:xfrm>
            <a:off x="8869" y="1954960"/>
            <a:ext cx="6884982" cy="363445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9162E5B8-E62B-91A1-D182-9507ECD97F27}"/>
              </a:ext>
            </a:extLst>
          </p:cNvPr>
          <p:cNvSpPr txBox="1"/>
          <p:nvPr/>
        </p:nvSpPr>
        <p:spPr>
          <a:xfrm>
            <a:off x="197641" y="2063405"/>
            <a:ext cx="348615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HH123-LPETG-His</a:t>
            </a:r>
            <a:r>
              <a:rPr lang="en-US" baseline="-25000" dirty="0"/>
              <a:t>6</a:t>
            </a:r>
          </a:p>
          <a:p>
            <a:endParaRPr lang="en-US" dirty="0"/>
          </a:p>
          <a:p>
            <a:r>
              <a:rPr lang="en-US" dirty="0"/>
              <a:t>Calculated mass: 15202 Da</a:t>
            </a:r>
          </a:p>
          <a:p>
            <a:r>
              <a:rPr lang="en-US" dirty="0"/>
              <a:t>Measured mass: 15204.0 Da  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E61E0855-2AFF-7EC9-2A42-22EDD1FF5C3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80" t="7541" r="8450" b="26309"/>
          <a:stretch/>
        </p:blipFill>
        <p:spPr>
          <a:xfrm>
            <a:off x="0" y="5820974"/>
            <a:ext cx="6884982" cy="363445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DD7B480E-9112-CFD4-B22D-4D82513EBC60}"/>
              </a:ext>
            </a:extLst>
          </p:cNvPr>
          <p:cNvSpPr txBox="1"/>
          <p:nvPr/>
        </p:nvSpPr>
        <p:spPr>
          <a:xfrm>
            <a:off x="188772" y="5929419"/>
            <a:ext cx="348615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HH188-LPETG-His</a:t>
            </a:r>
            <a:r>
              <a:rPr lang="en-US" baseline="-25000" dirty="0"/>
              <a:t>6</a:t>
            </a:r>
          </a:p>
          <a:p>
            <a:endParaRPr lang="en-US" dirty="0"/>
          </a:p>
          <a:p>
            <a:r>
              <a:rPr lang="en-US" dirty="0"/>
              <a:t>Calculated mass: 14008 Da</a:t>
            </a:r>
          </a:p>
          <a:p>
            <a:r>
              <a:rPr lang="en-US" dirty="0"/>
              <a:t>Measured mass: 14008.5 Da 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5C98FB8-433E-07F8-9F59-B6560699FE10}"/>
              </a:ext>
            </a:extLst>
          </p:cNvPr>
          <p:cNvSpPr txBox="1"/>
          <p:nvPr/>
        </p:nvSpPr>
        <p:spPr>
          <a:xfrm>
            <a:off x="71553" y="1110684"/>
            <a:ext cx="6759615" cy="7736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egend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LC/MS mass measurements of each V</a:t>
            </a:r>
            <a:r>
              <a:rPr lang="en-US" sz="14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 construct used in this work. PEG</a:t>
            </a:r>
            <a:r>
              <a:rPr lang="en-US" sz="14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0kDa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odified constructs are not shown as their masses cannot be precisely measured due to the fact that the DBCO-PEG</a:t>
            </a:r>
            <a:r>
              <a:rPr lang="en-US" sz="14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0kDa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mpound</a:t>
            </a:r>
            <a:r>
              <a:rPr lang="en-US" sz="14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as an </a:t>
            </a:r>
            <a:r>
              <a:rPr lang="en-US" sz="1400" u="sng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verage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ass of 20kDa.</a:t>
            </a:r>
            <a:endParaRPr lang="fr-BE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32353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A4EC9E54-26A8-CAF4-3614-BB4BD2DD40E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2" t="8947" r="8855" b="25280"/>
          <a:stretch/>
        </p:blipFill>
        <p:spPr>
          <a:xfrm>
            <a:off x="-4622" y="1148546"/>
            <a:ext cx="6884982" cy="363445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9162E5B8-E62B-91A1-D182-9507ECD97F27}"/>
              </a:ext>
            </a:extLst>
          </p:cNvPr>
          <p:cNvSpPr txBox="1"/>
          <p:nvPr/>
        </p:nvSpPr>
        <p:spPr>
          <a:xfrm>
            <a:off x="184150" y="1256991"/>
            <a:ext cx="348615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HH188-DFO-N</a:t>
            </a:r>
            <a:r>
              <a:rPr lang="en-US" baseline="-25000" dirty="0"/>
              <a:t>3</a:t>
            </a:r>
          </a:p>
          <a:p>
            <a:endParaRPr lang="en-US" dirty="0"/>
          </a:p>
          <a:p>
            <a:r>
              <a:rPr lang="en-US" dirty="0"/>
              <a:t>Calculated mass: 15120 Da</a:t>
            </a:r>
          </a:p>
          <a:p>
            <a:r>
              <a:rPr lang="en-US" dirty="0"/>
              <a:t>Measured mass: 15172.5 Da  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E61E0855-2AFF-7EC9-2A42-22EDD1FF5C3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78" t="8652" r="9349" b="25847"/>
          <a:stretch/>
        </p:blipFill>
        <p:spPr>
          <a:xfrm>
            <a:off x="-13491" y="5014560"/>
            <a:ext cx="6884982" cy="363445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DD7B480E-9112-CFD4-B22D-4D82513EBC60}"/>
              </a:ext>
            </a:extLst>
          </p:cNvPr>
          <p:cNvSpPr txBox="1"/>
          <p:nvPr/>
        </p:nvSpPr>
        <p:spPr>
          <a:xfrm>
            <a:off x="175281" y="5123005"/>
            <a:ext cx="348615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HH123-NOTA-N</a:t>
            </a:r>
            <a:r>
              <a:rPr lang="en-US" baseline="-25000" dirty="0"/>
              <a:t>3</a:t>
            </a:r>
          </a:p>
          <a:p>
            <a:endParaRPr lang="en-US" dirty="0"/>
          </a:p>
          <a:p>
            <a:r>
              <a:rPr lang="en-US" dirty="0"/>
              <a:t>Calculated mass: 15523 Da</a:t>
            </a:r>
          </a:p>
          <a:p>
            <a:r>
              <a:rPr lang="en-US" dirty="0"/>
              <a:t>Measured mass: 15521 Da  </a:t>
            </a:r>
          </a:p>
        </p:txBody>
      </p:sp>
    </p:spTree>
    <p:extLst>
      <p:ext uri="{BB962C8B-B14F-4D97-AF65-F5344CB8AC3E}">
        <p14:creationId xmlns:p14="http://schemas.microsoft.com/office/powerpoint/2010/main" val="23128993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A4EC9E54-26A8-CAF4-3614-BB4BD2DD40E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2" t="9044" r="8409" b="24860"/>
          <a:stretch/>
        </p:blipFill>
        <p:spPr>
          <a:xfrm>
            <a:off x="-4622" y="1148546"/>
            <a:ext cx="6884982" cy="363445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9162E5B8-E62B-91A1-D182-9507ECD97F27}"/>
              </a:ext>
            </a:extLst>
          </p:cNvPr>
          <p:cNvSpPr txBox="1"/>
          <p:nvPr/>
        </p:nvSpPr>
        <p:spPr>
          <a:xfrm>
            <a:off x="184150" y="1256991"/>
            <a:ext cx="348615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HH123-DFO-N</a:t>
            </a:r>
            <a:r>
              <a:rPr lang="en-US" baseline="-25000" dirty="0"/>
              <a:t>3</a:t>
            </a:r>
          </a:p>
          <a:p>
            <a:endParaRPr lang="en-US" dirty="0"/>
          </a:p>
          <a:p>
            <a:r>
              <a:rPr lang="en-US" dirty="0"/>
              <a:t>Calculated mass: 16314 Da</a:t>
            </a:r>
          </a:p>
          <a:p>
            <a:r>
              <a:rPr lang="en-US" dirty="0"/>
              <a:t>Measured mass: 16368.0 Da  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E61E0855-2AFF-7EC9-2A42-22EDD1FF5C3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17" t="8489" r="9326" b="26038"/>
          <a:stretch/>
        </p:blipFill>
        <p:spPr>
          <a:xfrm>
            <a:off x="-13491" y="5014560"/>
            <a:ext cx="6884982" cy="363445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DD7B480E-9112-CFD4-B22D-4D82513EBC60}"/>
              </a:ext>
            </a:extLst>
          </p:cNvPr>
          <p:cNvSpPr txBox="1"/>
          <p:nvPr/>
        </p:nvSpPr>
        <p:spPr>
          <a:xfrm>
            <a:off x="175281" y="5123005"/>
            <a:ext cx="348615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HH123-tetrazine</a:t>
            </a:r>
            <a:endParaRPr lang="en-US" baseline="-25000" dirty="0"/>
          </a:p>
          <a:p>
            <a:endParaRPr lang="en-US" dirty="0"/>
          </a:p>
          <a:p>
            <a:r>
              <a:rPr lang="en-US" dirty="0"/>
              <a:t>Calculated mass: 14891 Da</a:t>
            </a:r>
          </a:p>
          <a:p>
            <a:r>
              <a:rPr lang="en-US" dirty="0"/>
              <a:t>Measured mass: 14885 Da  </a:t>
            </a:r>
          </a:p>
        </p:txBody>
      </p:sp>
    </p:spTree>
    <p:extLst>
      <p:ext uri="{BB962C8B-B14F-4D97-AF65-F5344CB8AC3E}">
        <p14:creationId xmlns:p14="http://schemas.microsoft.com/office/powerpoint/2010/main" val="35873441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A4EC9E54-26A8-CAF4-3614-BB4BD2DD40E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1" t="8336" r="9003" b="25998"/>
          <a:stretch/>
        </p:blipFill>
        <p:spPr>
          <a:xfrm>
            <a:off x="-4622" y="1148546"/>
            <a:ext cx="6884982" cy="363445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9162E5B8-E62B-91A1-D182-9507ECD97F27}"/>
              </a:ext>
            </a:extLst>
          </p:cNvPr>
          <p:cNvSpPr txBox="1"/>
          <p:nvPr/>
        </p:nvSpPr>
        <p:spPr>
          <a:xfrm>
            <a:off x="184150" y="1256991"/>
            <a:ext cx="348615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HH188-tetrazine</a:t>
            </a:r>
            <a:endParaRPr lang="en-US" baseline="-25000" dirty="0"/>
          </a:p>
          <a:p>
            <a:endParaRPr lang="en-US" dirty="0"/>
          </a:p>
          <a:p>
            <a:r>
              <a:rPr lang="en-US" dirty="0"/>
              <a:t>Calculated mass: 13697 Da</a:t>
            </a:r>
          </a:p>
          <a:p>
            <a:r>
              <a:rPr lang="en-US" dirty="0"/>
              <a:t>Measured mass: 13694 Da  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E61E0855-2AFF-7EC9-2A42-22EDD1FF5C3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78" t="8501" r="9248" b="25924"/>
          <a:stretch/>
        </p:blipFill>
        <p:spPr>
          <a:xfrm>
            <a:off x="-13491" y="5014560"/>
            <a:ext cx="6884982" cy="363445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DD7B480E-9112-CFD4-B22D-4D82513EBC60}"/>
              </a:ext>
            </a:extLst>
          </p:cNvPr>
          <p:cNvSpPr txBox="1"/>
          <p:nvPr/>
        </p:nvSpPr>
        <p:spPr>
          <a:xfrm>
            <a:off x="175281" y="5123005"/>
            <a:ext cx="348615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HH123-biotin</a:t>
            </a:r>
            <a:endParaRPr lang="en-US" baseline="-25000" dirty="0"/>
          </a:p>
          <a:p>
            <a:endParaRPr lang="en-US" dirty="0"/>
          </a:p>
          <a:p>
            <a:r>
              <a:rPr lang="en-US" dirty="0"/>
              <a:t>Calculated mass: 15109 Da</a:t>
            </a:r>
          </a:p>
          <a:p>
            <a:r>
              <a:rPr lang="en-US" dirty="0"/>
              <a:t>Measured mass: 15103 Da  </a:t>
            </a:r>
          </a:p>
        </p:txBody>
      </p:sp>
    </p:spTree>
    <p:extLst>
      <p:ext uri="{BB962C8B-B14F-4D97-AF65-F5344CB8AC3E}">
        <p14:creationId xmlns:p14="http://schemas.microsoft.com/office/powerpoint/2010/main" val="36663934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A4EC9E54-26A8-CAF4-3614-BB4BD2DD40E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1" t="9069" r="9716" b="25780"/>
          <a:stretch/>
        </p:blipFill>
        <p:spPr>
          <a:xfrm>
            <a:off x="-4622" y="1148546"/>
            <a:ext cx="6884982" cy="363445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9162E5B8-E62B-91A1-D182-9507ECD97F27}"/>
              </a:ext>
            </a:extLst>
          </p:cNvPr>
          <p:cNvSpPr txBox="1"/>
          <p:nvPr/>
        </p:nvSpPr>
        <p:spPr>
          <a:xfrm>
            <a:off x="184150" y="1256991"/>
            <a:ext cx="348615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HH188-biotin</a:t>
            </a:r>
          </a:p>
          <a:p>
            <a:endParaRPr lang="en-US" dirty="0"/>
          </a:p>
          <a:p>
            <a:r>
              <a:rPr lang="en-US" dirty="0"/>
              <a:t>Calculated mass: 13915 Da</a:t>
            </a:r>
          </a:p>
          <a:p>
            <a:r>
              <a:rPr lang="en-US" dirty="0"/>
              <a:t>Measured mass: 13913 Da  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E61E0855-2AFF-7EC9-2A42-22EDD1FF5C3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16" t="8915" r="9583" b="25798"/>
          <a:stretch/>
        </p:blipFill>
        <p:spPr>
          <a:xfrm>
            <a:off x="-13491" y="5014560"/>
            <a:ext cx="6884982" cy="363445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DD7B480E-9112-CFD4-B22D-4D82513EBC60}"/>
              </a:ext>
            </a:extLst>
          </p:cNvPr>
          <p:cNvSpPr txBox="1"/>
          <p:nvPr/>
        </p:nvSpPr>
        <p:spPr>
          <a:xfrm>
            <a:off x="175281" y="5123005"/>
            <a:ext cx="348615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HHEnh-LPETG-His</a:t>
            </a:r>
            <a:r>
              <a:rPr lang="en-US" baseline="-25000" dirty="0"/>
              <a:t>6</a:t>
            </a:r>
          </a:p>
          <a:p>
            <a:endParaRPr lang="en-US" dirty="0"/>
          </a:p>
          <a:p>
            <a:r>
              <a:rPr lang="en-US" dirty="0"/>
              <a:t>Calculated mass: 14235 Da</a:t>
            </a:r>
          </a:p>
          <a:p>
            <a:r>
              <a:rPr lang="en-US" dirty="0"/>
              <a:t>Measured mass: 14233 Da  </a:t>
            </a:r>
          </a:p>
        </p:txBody>
      </p:sp>
    </p:spTree>
    <p:extLst>
      <p:ext uri="{BB962C8B-B14F-4D97-AF65-F5344CB8AC3E}">
        <p14:creationId xmlns:p14="http://schemas.microsoft.com/office/powerpoint/2010/main" val="175426331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A4EC9E54-26A8-CAF4-3614-BB4BD2DD40E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1" t="8316" r="9231" b="26181"/>
          <a:stretch/>
        </p:blipFill>
        <p:spPr>
          <a:xfrm>
            <a:off x="-4622" y="1148546"/>
            <a:ext cx="6884982" cy="363445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9162E5B8-E62B-91A1-D182-9507ECD97F27}"/>
              </a:ext>
            </a:extLst>
          </p:cNvPr>
          <p:cNvSpPr txBox="1"/>
          <p:nvPr/>
        </p:nvSpPr>
        <p:spPr>
          <a:xfrm>
            <a:off x="184150" y="1256991"/>
            <a:ext cx="348615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HHEnh-NOTA-N</a:t>
            </a:r>
            <a:r>
              <a:rPr lang="en-US" baseline="-25000" dirty="0"/>
              <a:t>3</a:t>
            </a:r>
            <a:endParaRPr lang="en-US" dirty="0"/>
          </a:p>
          <a:p>
            <a:endParaRPr lang="en-US" dirty="0"/>
          </a:p>
          <a:p>
            <a:r>
              <a:rPr lang="en-US" dirty="0"/>
              <a:t>Calculated mass: 14556 Da</a:t>
            </a:r>
          </a:p>
          <a:p>
            <a:r>
              <a:rPr lang="en-US" dirty="0"/>
              <a:t>Measured mass: 14555 Da  </a:t>
            </a:r>
          </a:p>
        </p:txBody>
      </p:sp>
    </p:spTree>
    <p:extLst>
      <p:ext uri="{BB962C8B-B14F-4D97-AF65-F5344CB8AC3E}">
        <p14:creationId xmlns:p14="http://schemas.microsoft.com/office/powerpoint/2010/main" val="20595934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72</Words>
  <Application>Microsoft Office PowerPoint</Application>
  <PresentationFormat>A4 Paper (210x297 mm)</PresentationFormat>
  <Paragraphs>4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ptos</vt:lpstr>
      <vt:lpstr>Aptos Display</vt:lpstr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homas Balligand</dc:creator>
  <cp:lastModifiedBy>Thomas Balligand</cp:lastModifiedBy>
  <cp:revision>2</cp:revision>
  <dcterms:created xsi:type="dcterms:W3CDTF">2025-07-23T13:30:30Z</dcterms:created>
  <dcterms:modified xsi:type="dcterms:W3CDTF">2025-07-24T09:22:44Z</dcterms:modified>
</cp:coreProperties>
</file>